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714" y="-8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0" y="2130440"/>
            <a:ext cx="84201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65331-B643-469A-BA18-3C023E326ABA}" type="datetimeFigureOut">
              <a:rPr kumimoji="1" lang="ja-JP" altLang="en-US" smtClean="0"/>
              <a:t>2013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F61CD-B2A9-4F07-9C89-6A5F938E3D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2246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65331-B643-469A-BA18-3C023E326ABA}" type="datetimeFigureOut">
              <a:rPr kumimoji="1" lang="ja-JP" altLang="en-US" smtClean="0"/>
              <a:t>2013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F61CD-B2A9-4F07-9C89-6A5F938E3D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5902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181850" y="274653"/>
            <a:ext cx="222885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95300" y="274653"/>
            <a:ext cx="652145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65331-B643-469A-BA18-3C023E326ABA}" type="datetimeFigureOut">
              <a:rPr kumimoji="1" lang="ja-JP" altLang="en-US" smtClean="0"/>
              <a:t>2013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F61CD-B2A9-4F07-9C89-6A5F938E3D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1348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65331-B643-469A-BA18-3C023E326ABA}" type="datetimeFigureOut">
              <a:rPr kumimoji="1" lang="ja-JP" altLang="en-US" smtClean="0"/>
              <a:t>2013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F61CD-B2A9-4F07-9C89-6A5F938E3D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5590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15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82506" y="2906722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65331-B643-469A-BA18-3C023E326ABA}" type="datetimeFigureOut">
              <a:rPr kumimoji="1" lang="ja-JP" altLang="en-US" smtClean="0"/>
              <a:t>2013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F61CD-B2A9-4F07-9C89-6A5F938E3D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7205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95300" y="1600206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035550" y="1600206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65331-B643-469A-BA18-3C023E326ABA}" type="datetimeFigureOut">
              <a:rPr kumimoji="1" lang="ja-JP" altLang="en-US" smtClean="0"/>
              <a:t>2013/12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F61CD-B2A9-4F07-9C89-6A5F938E3D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3913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65331-B643-469A-BA18-3C023E326ABA}" type="datetimeFigureOut">
              <a:rPr kumimoji="1" lang="ja-JP" altLang="en-US" smtClean="0"/>
              <a:t>2013/12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F61CD-B2A9-4F07-9C89-6A5F938E3D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4758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65331-B643-469A-BA18-3C023E326ABA}" type="datetimeFigureOut">
              <a:rPr kumimoji="1" lang="ja-JP" altLang="en-US" smtClean="0"/>
              <a:t>2013/12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F61CD-B2A9-4F07-9C89-6A5F938E3D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6186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65331-B643-469A-BA18-3C023E326ABA}" type="datetimeFigureOut">
              <a:rPr kumimoji="1" lang="ja-JP" altLang="en-US" smtClean="0"/>
              <a:t>2013/12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F61CD-B2A9-4F07-9C89-6A5F938E3D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3815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8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72978" y="273065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95308" y="1435103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65331-B643-469A-BA18-3C023E326ABA}" type="datetimeFigureOut">
              <a:rPr kumimoji="1" lang="ja-JP" altLang="en-US" smtClean="0"/>
              <a:t>2013/12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F61CD-B2A9-4F07-9C89-6A5F938E3D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711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65331-B643-469A-BA18-3C023E326ABA}" type="datetimeFigureOut">
              <a:rPr kumimoji="1" lang="ja-JP" altLang="en-US" smtClean="0"/>
              <a:t>2013/12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F61CD-B2A9-4F07-9C89-6A5F938E3D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8569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600206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95300" y="6356365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65331-B643-469A-BA18-3C023E326ABA}" type="datetimeFigureOut">
              <a:rPr kumimoji="1" lang="ja-JP" altLang="en-US" smtClean="0"/>
              <a:t>2013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84550" y="6356365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099300" y="6356365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8F61CD-B2A9-4F07-9C89-6A5F938E3D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3530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1019708"/>
              </p:ext>
            </p:extLst>
          </p:nvPr>
        </p:nvGraphicFramePr>
        <p:xfrm>
          <a:off x="632520" y="1052576"/>
          <a:ext cx="8856984" cy="518521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81822"/>
                <a:gridCol w="340366"/>
                <a:gridCol w="340366"/>
                <a:gridCol w="314184"/>
                <a:gridCol w="512004"/>
                <a:gridCol w="465457"/>
                <a:gridCol w="500367"/>
                <a:gridCol w="549821"/>
                <a:gridCol w="724369"/>
                <a:gridCol w="719985"/>
                <a:gridCol w="1025479"/>
                <a:gridCol w="794186"/>
                <a:gridCol w="742244"/>
                <a:gridCol w="1246334"/>
              </a:tblGrid>
              <a:tr h="327516">
                <a:tc>
                  <a:txBody>
                    <a:bodyPr/>
                    <a:lstStyle/>
                    <a:p>
                      <a:pPr algn="ctr" fontAlgn="b"/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Cas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age</a:t>
                      </a:r>
                      <a:endParaRPr lang="en-US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CLD (cm)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Interval* (</a:t>
                      </a:r>
                      <a:r>
                        <a:rPr lang="en-US" sz="1050" u="none" strike="noStrike" dirty="0" err="1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mo</a:t>
                      </a:r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)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cough</a:t>
                      </a:r>
                      <a:endParaRPr lang="en-US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fever</a:t>
                      </a:r>
                      <a:endParaRPr lang="en-US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dyspnea</a:t>
                      </a:r>
                      <a:endParaRPr lang="en-US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Symptom</a:t>
                      </a:r>
                      <a:r>
                        <a:rPr lang="en-US" altLang="ja-JP" sz="1050" u="none" strike="noStrike" baseline="30000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†</a:t>
                      </a:r>
                      <a:endParaRPr lang="en-US" sz="1050" u="none" strike="noStrike" baseline="30000" dirty="0" smtClean="0"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  <a:p>
                      <a:pPr algn="ctr" fontAlgn="b"/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(</a:t>
                      </a:r>
                      <a:r>
                        <a:rPr lang="en-US" sz="1050" u="none" strike="noStrike" dirty="0" err="1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mo</a:t>
                      </a:r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)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Migratory progression</a:t>
                      </a: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Relapse</a:t>
                      </a:r>
                      <a:r>
                        <a:rPr lang="en-US" altLang="ja-JP" sz="1050" u="none" strike="noStrike" baseline="30000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‡</a:t>
                      </a:r>
                      <a:endParaRPr lang="en-US" sz="105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 err="1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Stabilation</a:t>
                      </a:r>
                      <a:r>
                        <a:rPr lang="en-US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 </a:t>
                      </a:r>
                      <a:br>
                        <a:rPr lang="en-US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</a:br>
                      <a:r>
                        <a:rPr lang="en-US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of shadow </a:t>
                      </a:r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(</a:t>
                      </a:r>
                      <a:r>
                        <a:rPr lang="en-US" sz="1050" u="none" strike="noStrike" dirty="0" err="1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mo</a:t>
                      </a:r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)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50" u="none" strike="noStrike" baseline="0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Duration of RIOP</a:t>
                      </a:r>
                      <a:r>
                        <a:rPr lang="en-US" altLang="ja-JP" sz="1050" u="none" strike="noStrike" baseline="30000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||</a:t>
                      </a:r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 </a:t>
                      </a:r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 (</a:t>
                      </a:r>
                      <a:r>
                        <a:rPr lang="en-US" sz="1050" u="none" strike="noStrike" dirty="0" err="1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mo</a:t>
                      </a:r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)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Reason</a:t>
                      </a:r>
                      <a:r>
                        <a:rPr lang="en-US" sz="1050" u="none" strike="noStrike" baseline="0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 for </a:t>
                      </a:r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Steroid</a:t>
                      </a:r>
                      <a:r>
                        <a:rPr lang="en-US" sz="1050" u="none" strike="noStrike" baseline="0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 </a:t>
                      </a:r>
                      <a:r>
                        <a:rPr lang="en-US" sz="1050" u="none" strike="noStrike" baseline="0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Administration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Steroid </a:t>
                      </a:r>
                    </a:p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Group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5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7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.2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NA</a:t>
                      </a:r>
                      <a:endParaRPr lang="en-US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0 mo, once</a:t>
                      </a:r>
                      <a:endParaRPr lang="en-US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2.7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7.5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Before</a:t>
                      </a:r>
                      <a:r>
                        <a:rPr lang="en-US" sz="105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 2001</a:t>
                      </a:r>
                      <a:r>
                        <a:rPr lang="en-US" sz="1050" b="0" i="0" u="none" strike="noStrike" baseline="30000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#</a:t>
                      </a:r>
                      <a:endParaRPr lang="en-US" sz="1050" b="0" i="0" u="none" strike="noStrike" baseline="30000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70C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7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9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1.9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9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7.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Before</a:t>
                      </a:r>
                      <a:r>
                        <a:rPr lang="en-US" sz="105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 2001</a:t>
                      </a:r>
                      <a:r>
                        <a:rPr lang="en-US" altLang="ja-JP" sz="1050" b="0" i="0" u="none" strike="noStrike" baseline="30000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#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70C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 anchor="ctr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4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4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9 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5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2 mo, 14 times</a:t>
                      </a:r>
                      <a:endParaRPr lang="en-US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32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60.1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Before</a:t>
                      </a:r>
                      <a:r>
                        <a:rPr lang="en-US" sz="105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 2001</a:t>
                      </a:r>
                      <a:r>
                        <a:rPr lang="en-US" altLang="ja-JP" sz="1050" b="0" i="0" u="none" strike="noStrike" baseline="30000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#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70C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2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2 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3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6 mo, once</a:t>
                      </a:r>
                      <a:endParaRPr lang="en-US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4.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Prolonged </a:t>
                      </a:r>
                      <a:r>
                        <a:rPr lang="en-US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symptom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70C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4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6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5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8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9.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Prolonged</a:t>
                      </a:r>
                      <a:r>
                        <a:rPr lang="en-US" sz="1050" u="none" strike="noStrike" baseline="0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 </a:t>
                      </a:r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symptom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70C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5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2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1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.5 </a:t>
                      </a:r>
                      <a:r>
                        <a:rPr lang="en-US" sz="1050" u="none" strike="noStrike" dirty="0" err="1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mo</a:t>
                      </a:r>
                      <a:r>
                        <a:rPr lang="en-US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, twic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9.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5.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Prolonged symptom 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70C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accent5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42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4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6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3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4 mo, twice</a:t>
                      </a:r>
                      <a:endParaRPr lang="en-US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7.7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History of Asthma</a:t>
                      </a:r>
                      <a:r>
                        <a:rPr lang="en-US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 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rowSpan="19"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Non-steroid</a:t>
                      </a:r>
                    </a:p>
                    <a:p>
                      <a:pPr algn="ctr" fontAlgn="t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Group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8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1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3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0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3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3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9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8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2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.2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1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7.1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1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2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8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0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2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4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2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37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71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6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6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1.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3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1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4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7.9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96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4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1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4.1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2.8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47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5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2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7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0.7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7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3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7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0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.4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.4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.4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4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.7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2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8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9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3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8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8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2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.5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0.8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.5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9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5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2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.3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5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2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.7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5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37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4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0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1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2.2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5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4.1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7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7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71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2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6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0.5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2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0.5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2377">
                <a:tc vMerge="1">
                  <a:txBody>
                    <a:bodyPr/>
                    <a:lstStyle/>
                    <a:p>
                      <a:pPr algn="r" fontAlgn="t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2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2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4.6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5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.8 </a:t>
                      </a:r>
                      <a:r>
                        <a:rPr lang="en-US" sz="1050" u="none" strike="noStrike" dirty="0" err="1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mo</a:t>
                      </a:r>
                      <a:r>
                        <a:rPr lang="en-US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, onc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0.4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5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B05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7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7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0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7.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5 mo, once</a:t>
                      </a:r>
                      <a:endParaRPr lang="en-US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0.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7.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 vMerge="1">
                  <a:txBody>
                    <a:bodyPr/>
                    <a:lstStyle/>
                    <a:p>
                      <a:pPr algn="r" fontAlgn="ctr"/>
                      <a:endParaRPr lang="en-US" altLang="ja-JP" sz="800" b="0" i="0" u="none" strike="noStrike" dirty="0">
                        <a:solidFill>
                          <a:srgbClr val="0070C0"/>
                        </a:solidFill>
                        <a:effectLst/>
                        <a:latin typeface="ＭＳ Ｐゴシック"/>
                      </a:endParaRPr>
                    </a:p>
                  </a:txBody>
                  <a:tcPr marL="7217" marR="7217" marT="6662" marB="0"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60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5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7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+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3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3 mo, 3 times</a:t>
                      </a:r>
                      <a:endParaRPr lang="en-US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9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9.6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Relaps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Median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59.0 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.1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1 </a:t>
                      </a:r>
                      <a:endParaRPr lang="en-US" altLang="ja-JP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N/A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N/A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N/A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.8 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N/A</a:t>
                      </a:r>
                      <a:endParaRPr lang="ja-JP" altLang="en-US" sz="1050" b="0" i="0" u="none" strike="noStrike" dirty="0" smtClean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N/A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7.8 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 smtClean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3.9 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6357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50" u="none" strike="noStrike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Sum</a:t>
                      </a:r>
                      <a:endParaRPr lang="en-US" sz="1050" b="0" i="0" u="none" strike="noStrike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N/A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N/A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N/A</a:t>
                      </a:r>
                      <a:endParaRPr lang="ja-JP" altLang="en-US" sz="1050" b="0" i="0" u="none" strike="noStrike" dirty="0" smtClean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22 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11 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7 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N/A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9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8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N/A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itchFamily="50" charset="-128"/>
                          <a:ea typeface="Arial Unicode MS" pitchFamily="50" charset="-128"/>
                          <a:cs typeface="Arial Unicode MS" pitchFamily="50" charset="-128"/>
                        </a:rPr>
                        <a:t>-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itchFamily="50" charset="-128"/>
                        <a:ea typeface="Arial Unicode MS" pitchFamily="50" charset="-128"/>
                        <a:cs typeface="Arial Unicode MS" pitchFamily="50" charset="-128"/>
                      </a:endParaRPr>
                    </a:p>
                  </a:txBody>
                  <a:tcPr marL="7217" marR="7217" marT="666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3224811" y="499094"/>
            <a:ext cx="46213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Table S1. Clinical Characteristics of the Patients </a:t>
            </a:r>
            <a:endParaRPr kumimoji="1"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704532" y="6380311"/>
            <a:ext cx="9433048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baseline="30000" dirty="0"/>
              <a:t>*</a:t>
            </a:r>
            <a:r>
              <a:rPr lang="en-US" altLang="ja-JP" sz="1050" dirty="0"/>
              <a:t>:</a:t>
            </a:r>
            <a:r>
              <a:rPr lang="en-US" altLang="ja-JP" sz="1050" baseline="30000" dirty="0"/>
              <a:t> </a:t>
            </a:r>
            <a:r>
              <a:rPr lang="en-US" altLang="ja-JP" sz="1050" dirty="0"/>
              <a:t>Time from completion of radiotherapy to onset, </a:t>
            </a:r>
            <a:r>
              <a:rPr lang="ja-JP" altLang="ja-JP" sz="1050" baseline="30000" dirty="0"/>
              <a:t>†</a:t>
            </a:r>
            <a:r>
              <a:rPr lang="en-US" altLang="ja-JP" sz="1050" dirty="0"/>
              <a:t>:</a:t>
            </a:r>
            <a:r>
              <a:rPr lang="en-US" altLang="ja-JP" sz="1050" baseline="30000" dirty="0"/>
              <a:t> </a:t>
            </a:r>
            <a:r>
              <a:rPr lang="en-US" altLang="ja-JP" sz="1050" dirty="0"/>
              <a:t>Time from onset to disappearance of the first symptom, </a:t>
            </a:r>
            <a:r>
              <a:rPr lang="en-US" altLang="ja-JP" sz="1050" baseline="30000" dirty="0"/>
              <a:t>‡</a:t>
            </a:r>
            <a:r>
              <a:rPr lang="en-US" altLang="ja-JP" sz="1050" dirty="0"/>
              <a:t>:</a:t>
            </a:r>
            <a:r>
              <a:rPr lang="en-US" altLang="ja-JP" sz="1050" baseline="30000" dirty="0"/>
              <a:t> </a:t>
            </a:r>
            <a:r>
              <a:rPr lang="en-US" altLang="ja-JP" sz="1050" dirty="0"/>
              <a:t>Times of relapses, </a:t>
            </a:r>
            <a:r>
              <a:rPr lang="en-US" altLang="ja-JP" sz="1050" baseline="30000" dirty="0"/>
              <a:t>||</a:t>
            </a:r>
            <a:r>
              <a:rPr lang="en-US" altLang="ja-JP" sz="1050" dirty="0"/>
              <a:t>: Time from onset to be free from symptoms, steroid and other medications, #: The practice of routine corticosteroid administration prior </a:t>
            </a:r>
            <a:r>
              <a:rPr lang="en-US" altLang="ja-JP" sz="1050"/>
              <a:t>to </a:t>
            </a:r>
            <a:r>
              <a:rPr lang="en-US" altLang="ja-JP" sz="1050" smtClean="0"/>
              <a:t>2001.  </a:t>
            </a:r>
            <a:r>
              <a:rPr lang="en-US" altLang="ja-JP" sz="1050" dirty="0"/>
              <a:t>Abbreviations: </a:t>
            </a:r>
            <a:r>
              <a:rPr lang="en-US" altLang="ja-JP" sz="1050" dirty="0" err="1"/>
              <a:t>mo</a:t>
            </a:r>
            <a:r>
              <a:rPr lang="en-US" altLang="ja-JP" sz="1050" dirty="0"/>
              <a:t> = months, N/A = not available</a:t>
            </a:r>
            <a:endParaRPr lang="ja-JP" altLang="ja-JP" sz="1050" dirty="0"/>
          </a:p>
          <a:p>
            <a:r>
              <a:rPr lang="en-US" altLang="ja-JP" sz="1050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 </a:t>
            </a:r>
            <a:r>
              <a:rPr kumimoji="1" lang="en-US" altLang="ja-JP" sz="1050" dirty="0" smtClean="0"/>
              <a:t> 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11432469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グレースケール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DDDDDD"/>
      </a:accent1>
      <a:accent2>
        <a:srgbClr val="B2B2B2"/>
      </a:accent2>
      <a:accent3>
        <a:srgbClr val="969696"/>
      </a:accent3>
      <a:accent4>
        <a:srgbClr val="808080"/>
      </a:accent4>
      <a:accent5>
        <a:srgbClr val="5F5F5F"/>
      </a:accent5>
      <a:accent6>
        <a:srgbClr val="4D4D4D"/>
      </a:accent6>
      <a:hlink>
        <a:srgbClr val="5F5F5F"/>
      </a:hlink>
      <a:folHlink>
        <a:srgbClr val="919191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5</TotalTime>
  <Words>493</Words>
  <Application>Microsoft Office PowerPoint</Application>
  <PresentationFormat>A4 210 x 297 mm</PresentationFormat>
  <Paragraphs>36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IOP figures</dc:title>
  <dc:creator>Keisuke OHTANI</dc:creator>
  <cp:lastModifiedBy>K. Otani</cp:lastModifiedBy>
  <cp:revision>75</cp:revision>
  <dcterms:created xsi:type="dcterms:W3CDTF">2011-05-03T13:32:35Z</dcterms:created>
  <dcterms:modified xsi:type="dcterms:W3CDTF">2013-12-15T14:53:07Z</dcterms:modified>
</cp:coreProperties>
</file>